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635EF15-2B71-4EF8-8062-B03B3F0EC0B6}" v="1" dt="2023-12-13T16:43:25.84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3" d="100"/>
          <a:sy n="73" d="100"/>
        </p:scale>
        <p:origin x="380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ielian, Tammy L" userId="33314709-a390-487d-b8c2-aed94e11162d" providerId="ADAL" clId="{4635EF15-2B71-4EF8-8062-B03B3F0EC0B6}"/>
    <pc:docChg chg="modSld">
      <pc:chgData name="Kielian, Tammy L" userId="33314709-a390-487d-b8c2-aed94e11162d" providerId="ADAL" clId="{4635EF15-2B71-4EF8-8062-B03B3F0EC0B6}" dt="2023-12-13T16:43:36.895" v="15" actId="14100"/>
      <pc:docMkLst>
        <pc:docMk/>
      </pc:docMkLst>
      <pc:sldChg chg="addSp modSp mod">
        <pc:chgData name="Kielian, Tammy L" userId="33314709-a390-487d-b8c2-aed94e11162d" providerId="ADAL" clId="{4635EF15-2B71-4EF8-8062-B03B3F0EC0B6}" dt="2023-12-13T16:43:36.895" v="15" actId="14100"/>
        <pc:sldMkLst>
          <pc:docMk/>
          <pc:sldMk cId="266287942" sldId="260"/>
        </pc:sldMkLst>
        <pc:spChg chg="mod">
          <ac:chgData name="Kielian, Tammy L" userId="33314709-a390-487d-b8c2-aed94e11162d" providerId="ADAL" clId="{4635EF15-2B71-4EF8-8062-B03B3F0EC0B6}" dt="2023-12-12T19:12:16.422" v="0" actId="1076"/>
          <ac:spMkLst>
            <pc:docMk/>
            <pc:sldMk cId="266287942" sldId="260"/>
            <ac:spMk id="4" creationId="{D3107955-42A5-6AC5-00A6-0FA306F5478C}"/>
          </ac:spMkLst>
        </pc:spChg>
        <pc:spChg chg="mod">
          <ac:chgData name="Kielian, Tammy L" userId="33314709-a390-487d-b8c2-aed94e11162d" providerId="ADAL" clId="{4635EF15-2B71-4EF8-8062-B03B3F0EC0B6}" dt="2023-12-12T19:12:16.422" v="0" actId="1076"/>
          <ac:spMkLst>
            <pc:docMk/>
            <pc:sldMk cId="266287942" sldId="260"/>
            <ac:spMk id="5" creationId="{3E91278E-B787-7D8C-5A35-6616238C40A6}"/>
          </ac:spMkLst>
        </pc:spChg>
        <pc:spChg chg="add mod">
          <ac:chgData name="Kielian, Tammy L" userId="33314709-a390-487d-b8c2-aed94e11162d" providerId="ADAL" clId="{4635EF15-2B71-4EF8-8062-B03B3F0EC0B6}" dt="2023-12-13T16:43:14.856" v="12" actId="1036"/>
          <ac:spMkLst>
            <pc:docMk/>
            <pc:sldMk cId="266287942" sldId="260"/>
            <ac:spMk id="9" creationId="{C54EF5D3-E9F3-9C24-382C-6DB75A75B234}"/>
          </ac:spMkLst>
        </pc:spChg>
        <pc:spChg chg="add mod">
          <ac:chgData name="Kielian, Tammy L" userId="33314709-a390-487d-b8c2-aed94e11162d" providerId="ADAL" clId="{4635EF15-2B71-4EF8-8062-B03B3F0EC0B6}" dt="2023-12-13T16:43:36.895" v="15" actId="14100"/>
          <ac:spMkLst>
            <pc:docMk/>
            <pc:sldMk cId="266287942" sldId="260"/>
            <ac:spMk id="10" creationId="{BF6B6795-4478-4570-B370-F77D1C03E6D2}"/>
          </ac:spMkLst>
        </pc:spChg>
        <pc:grpChg chg="mod">
          <ac:chgData name="Kielian, Tammy L" userId="33314709-a390-487d-b8c2-aed94e11162d" providerId="ADAL" clId="{4635EF15-2B71-4EF8-8062-B03B3F0EC0B6}" dt="2023-12-12T19:12:16.422" v="0" actId="1076"/>
          <ac:grpSpMkLst>
            <pc:docMk/>
            <pc:sldMk cId="266287942" sldId="260"/>
            <ac:grpSpMk id="2" creationId="{1725CA3D-25CE-7161-CE26-23F34B658F4D}"/>
          </ac:grpSpMkLst>
        </pc:grpChg>
        <pc:grpChg chg="mod">
          <ac:chgData name="Kielian, Tammy L" userId="33314709-a390-487d-b8c2-aed94e11162d" providerId="ADAL" clId="{4635EF15-2B71-4EF8-8062-B03B3F0EC0B6}" dt="2023-12-12T19:12:16.422" v="0" actId="1076"/>
          <ac:grpSpMkLst>
            <pc:docMk/>
            <pc:sldMk cId="266287942" sldId="260"/>
            <ac:grpSpMk id="68" creationId="{85BA058E-BDCC-F158-6C4D-5068B6C1853B}"/>
          </ac:grpSpMkLst>
        </pc:gr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3BF0ED-EA37-AB24-7C24-53CB82C24CF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F635851-5D50-E4D3-FE50-C1EB2DFC52B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B6E44F3-9254-ABA8-C311-BE2F2734CD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2CFACD-19D4-4A62-9116-E59EA4DD321C}" type="datetimeFigureOut">
              <a:rPr lang="en-US" smtClean="0"/>
              <a:t>12/1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D856B2-030E-4454-522C-AA91E4AF48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3B1530-AFB6-773F-DC3D-545911797D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8D2AD8-6D01-4B98-B1D6-86D014EAB6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25296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242FD9-DDD6-FFA8-710C-D1C3FA0E13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D8E4A13-D4F1-28BB-11F5-3107961645E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152AF4-6B8E-AE4A-3FB0-C67FB84FE0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2CFACD-19D4-4A62-9116-E59EA4DD321C}" type="datetimeFigureOut">
              <a:rPr lang="en-US" smtClean="0"/>
              <a:t>12/1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B97DA9-5C4E-729F-F6E7-475A6733FB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9B53A4D-D117-E9C9-46D1-175EBC3EFD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8D2AD8-6D01-4B98-B1D6-86D014EAB6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25976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E06FE47-9D78-95D2-0869-76F10781912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A9BC8CE-BF90-C409-0A84-4A005135AB0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5DA8FC-71B1-0740-F0C7-46B651714B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2CFACD-19D4-4A62-9116-E59EA4DD321C}" type="datetimeFigureOut">
              <a:rPr lang="en-US" smtClean="0"/>
              <a:t>12/1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D2B2B0-03E0-C0E6-BA30-87A961C2DD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5A70A9-1593-AF60-415C-AF6E42390B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8D2AD8-6D01-4B98-B1D6-86D014EAB6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30406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499D74-B7DF-81A4-C14C-922386E85A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AC03924-9ECE-B7AE-E4BC-B543BD124FC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0C80C9-4D1F-01C6-26DA-49096D6066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2CFACD-19D4-4A62-9116-E59EA4DD321C}" type="datetimeFigureOut">
              <a:rPr lang="en-US" smtClean="0"/>
              <a:t>12/1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D24FF1-C2C9-7EC8-E4EE-DFE72C4F0B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FCC43D-166D-1FB6-221F-D97656E4B6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8D2AD8-6D01-4B98-B1D6-86D014EAB6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87252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8A023C-B895-62AB-14BD-109B1AC4AA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0C1D143-F4BB-A1D2-2753-A139FA2BCDC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DEB8B3-F820-1E70-8EFE-AA193DD244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2CFACD-19D4-4A62-9116-E59EA4DD321C}" type="datetimeFigureOut">
              <a:rPr lang="en-US" smtClean="0"/>
              <a:t>12/1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9938BFB-8D03-2752-055B-82190980B6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A4F0FA-005F-E7F9-E57F-6EFB05D3E2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8D2AD8-6D01-4B98-B1D6-86D014EAB6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71494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F5F152-1D72-8BE5-9522-16F54849EB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3F13F56-DCCF-E935-1B71-B9D5C7EF9A7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DAABD39-8E73-F260-BE2A-5E77383D1C1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24B5C5A-EDE1-705A-924F-413F459EDC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2CFACD-19D4-4A62-9116-E59EA4DD321C}" type="datetimeFigureOut">
              <a:rPr lang="en-US" smtClean="0"/>
              <a:t>12/1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47FFD91-2939-A35A-C551-3B1E5C34F3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7EF3FB1-5B50-2A07-259F-052AE03B39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8D2AD8-6D01-4B98-B1D6-86D014EAB6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39990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4A95C3-F1B9-5689-064A-93358E6638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CCF5F63-5537-6DDB-9DDF-45E0C2738A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76D9DB8-FBF0-FC15-8B19-4B76E2B7A85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7D4BC09-286D-CB45-554D-3355BBE1B10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DB8A8D2-1A60-85F2-203B-3947E38B32B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C313BD7-ADBF-0804-F55F-346B302FD8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2CFACD-19D4-4A62-9116-E59EA4DD321C}" type="datetimeFigureOut">
              <a:rPr lang="en-US" smtClean="0"/>
              <a:t>12/13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824C9BF-8D4B-32D7-DCF9-7F1B12599C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71093EF-A468-DA4C-B0AF-538C572A56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8D2AD8-6D01-4B98-B1D6-86D014EAB6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10229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3F7C7D-2C05-E4A8-A7DA-4E0FA78A17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E755AA2-3AE3-BA3A-CC69-7FED0DAD10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2CFACD-19D4-4A62-9116-E59EA4DD321C}" type="datetimeFigureOut">
              <a:rPr lang="en-US" smtClean="0"/>
              <a:t>12/13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CCE42E1-93B0-7EFB-3B50-597F597FF6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E2F6A94-390D-6AAD-D9EB-B85CF5D1F6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8D2AD8-6D01-4B98-B1D6-86D014EAB6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6357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7EEE07A-8AAC-C515-E4C5-1B15A7180B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2CFACD-19D4-4A62-9116-E59EA4DD321C}" type="datetimeFigureOut">
              <a:rPr lang="en-US" smtClean="0"/>
              <a:t>12/13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15BD494-C271-C643-1853-CF3875CC67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6DD9E3C-CD4C-8C83-FA25-04F8B72952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8D2AD8-6D01-4B98-B1D6-86D014EAB6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17080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5F89FA-8C9F-D150-AC26-D29639310E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AA98D42-8B3B-4CC9-C014-ED8DF8880C9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C184413-360D-2177-CD8F-5F18BC20656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4FC0521-0813-49C3-018B-2EE066D654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2CFACD-19D4-4A62-9116-E59EA4DD321C}" type="datetimeFigureOut">
              <a:rPr lang="en-US" smtClean="0"/>
              <a:t>12/1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955363A-236A-60DB-44E3-5F7CAD1660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34E7473-26E6-ACE7-6365-7557F7AF8D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8D2AD8-6D01-4B98-B1D6-86D014EAB6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86579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7B830F-266C-F2F4-BAF6-81ECFE1083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D6B51F9-8C36-763D-BAAB-9B5831120BA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405C846-5D3A-6C77-B128-9C0CC34AC54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DAB13F9-B3F7-2CF8-43CB-56EB9F47C4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2CFACD-19D4-4A62-9116-E59EA4DD321C}" type="datetimeFigureOut">
              <a:rPr lang="en-US" smtClean="0"/>
              <a:t>12/1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976AE3D-20EC-5965-B9D5-99983D457C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30C00E4-D6E7-8658-8A20-8290057567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8D2AD8-6D01-4B98-B1D6-86D014EAB6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1817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0BF3355-F9F2-8767-EE1B-B3F2980810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D455AE8-0937-A50F-C7E8-1676A6C759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B694F1-CC00-F138-A968-AE9CFE94F8F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2CFACD-19D4-4A62-9116-E59EA4DD321C}" type="datetimeFigureOut">
              <a:rPr lang="en-US" smtClean="0"/>
              <a:t>12/1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A3254EC-847D-1310-DEFB-C989C027A5D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C8C781-E606-59B5-7FC2-E33D444C46D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8D2AD8-6D01-4B98-B1D6-86D014EAB6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04450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1725CA3D-25CE-7161-CE26-23F34B658F4D}"/>
              </a:ext>
            </a:extLst>
          </p:cNvPr>
          <p:cNvGrpSpPr/>
          <p:nvPr/>
        </p:nvGrpSpPr>
        <p:grpSpPr>
          <a:xfrm>
            <a:off x="1852648" y="2190599"/>
            <a:ext cx="3829391" cy="2476802"/>
            <a:chOff x="937000" y="213391"/>
            <a:chExt cx="3829391" cy="2476802"/>
          </a:xfrm>
        </p:grpSpPr>
        <p:pic>
          <p:nvPicPr>
            <p:cNvPr id="3" name="Picture 2" descr="A picture containing text&#10;&#10;Description automatically generated">
              <a:extLst>
                <a:ext uri="{FF2B5EF4-FFF2-40B4-BE49-F238E27FC236}">
                  <a16:creationId xmlns:a16="http://schemas.microsoft.com/office/drawing/2014/main" id="{066BB5F3-4ECB-6556-EE8C-4D0380A69C0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760" t="30850" r="29263" b="35391"/>
            <a:stretch/>
          </p:blipFill>
          <p:spPr>
            <a:xfrm>
              <a:off x="1490082" y="861393"/>
              <a:ext cx="2661220" cy="1828800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13AFD86D-6A84-FC91-A35E-841573273B9F}"/>
                </a:ext>
              </a:extLst>
            </p:cNvPr>
            <p:cNvSpPr txBox="1"/>
            <p:nvPr/>
          </p:nvSpPr>
          <p:spPr>
            <a:xfrm>
              <a:off x="937000" y="894724"/>
              <a:ext cx="70243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260 </a:t>
              </a:r>
              <a:r>
                <a:rPr lang="en-US" sz="1200" b="1" dirty="0" err="1"/>
                <a:t>kDa</a:t>
              </a:r>
              <a:endParaRPr lang="en-US" sz="1200" b="1" dirty="0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14A5880C-5747-08E4-CA62-E4EE41659968}"/>
                </a:ext>
              </a:extLst>
            </p:cNvPr>
            <p:cNvSpPr txBox="1"/>
            <p:nvPr/>
          </p:nvSpPr>
          <p:spPr>
            <a:xfrm>
              <a:off x="937000" y="1109270"/>
              <a:ext cx="70243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125 </a:t>
              </a:r>
              <a:r>
                <a:rPr lang="en-US" sz="1200" b="1" dirty="0" err="1"/>
                <a:t>kDa</a:t>
              </a:r>
              <a:endParaRPr lang="en-US" sz="1200" b="1" dirty="0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ABF21C35-D50C-ABDA-1453-62183FCE536E}"/>
                </a:ext>
              </a:extLst>
            </p:cNvPr>
            <p:cNvSpPr txBox="1"/>
            <p:nvPr/>
          </p:nvSpPr>
          <p:spPr>
            <a:xfrm>
              <a:off x="1015547" y="1290404"/>
              <a:ext cx="62388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90 </a:t>
              </a:r>
              <a:r>
                <a:rPr lang="en-US" sz="1200" b="1" dirty="0" err="1"/>
                <a:t>kDa</a:t>
              </a:r>
              <a:endParaRPr lang="en-US" sz="1200" b="1" dirty="0"/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3ECB4926-476A-F9F2-0D20-1871C7030CA2}"/>
                </a:ext>
              </a:extLst>
            </p:cNvPr>
            <p:cNvSpPr txBox="1"/>
            <p:nvPr/>
          </p:nvSpPr>
          <p:spPr>
            <a:xfrm>
              <a:off x="1015547" y="1927103"/>
              <a:ext cx="62388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38 </a:t>
              </a:r>
              <a:r>
                <a:rPr lang="en-US" sz="1200" b="1" dirty="0" err="1"/>
                <a:t>kDa</a:t>
              </a:r>
              <a:endParaRPr lang="en-US" sz="1200" b="1" dirty="0"/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E895758A-7B9A-F5F2-CC67-FA78ACC073D2}"/>
                </a:ext>
              </a:extLst>
            </p:cNvPr>
            <p:cNvSpPr txBox="1"/>
            <p:nvPr/>
          </p:nvSpPr>
          <p:spPr>
            <a:xfrm>
              <a:off x="4102427" y="1496344"/>
              <a:ext cx="66396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HIF-1α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F947A09D-D40D-9D42-125F-8ECF0CABA794}"/>
                </a:ext>
              </a:extLst>
            </p:cNvPr>
            <p:cNvSpPr txBox="1"/>
            <p:nvPr/>
          </p:nvSpPr>
          <p:spPr>
            <a:xfrm>
              <a:off x="1893649" y="213391"/>
              <a:ext cx="110083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G-MDSC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C397F00F-1FA6-2251-E8DB-EB051234CA34}"/>
                </a:ext>
              </a:extLst>
            </p:cNvPr>
            <p:cNvSpPr txBox="1"/>
            <p:nvPr/>
          </p:nvSpPr>
          <p:spPr>
            <a:xfrm>
              <a:off x="3065502" y="213391"/>
              <a:ext cx="10386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r>
                <a:rPr lang="el-G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φ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5" name="Straight Connector 54">
              <a:extLst>
                <a:ext uri="{FF2B5EF4-FFF2-40B4-BE49-F238E27FC236}">
                  <a16:creationId xmlns:a16="http://schemas.microsoft.com/office/drawing/2014/main" id="{0C33509D-2560-F9D3-5161-8507B2B1D1E4}"/>
                </a:ext>
              </a:extLst>
            </p:cNvPr>
            <p:cNvCxnSpPr>
              <a:cxnSpLocks/>
            </p:cNvCxnSpPr>
            <p:nvPr/>
          </p:nvCxnSpPr>
          <p:spPr>
            <a:xfrm>
              <a:off x="1875893" y="479821"/>
              <a:ext cx="1100831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Straight Connector 55">
              <a:extLst>
                <a:ext uri="{FF2B5EF4-FFF2-40B4-BE49-F238E27FC236}">
                  <a16:creationId xmlns:a16="http://schemas.microsoft.com/office/drawing/2014/main" id="{345D0116-14D6-3CDB-AB89-C5F8E2727161}"/>
                </a:ext>
              </a:extLst>
            </p:cNvPr>
            <p:cNvCxnSpPr>
              <a:cxnSpLocks/>
            </p:cNvCxnSpPr>
            <p:nvPr/>
          </p:nvCxnSpPr>
          <p:spPr>
            <a:xfrm>
              <a:off x="3037794" y="479821"/>
              <a:ext cx="1100831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AD97239D-2B36-8CC1-5B61-2D71D34BC88F}"/>
                </a:ext>
              </a:extLst>
            </p:cNvPr>
            <p:cNvSpPr txBox="1"/>
            <p:nvPr/>
          </p:nvSpPr>
          <p:spPr>
            <a:xfrm>
              <a:off x="1786217" y="646316"/>
              <a:ext cx="4154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Mrp8</a:t>
              </a:r>
              <a:r>
                <a:rPr lang="en-US" sz="5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Null</a:t>
              </a:r>
              <a:br>
                <a:rPr lang="en-US" sz="500" b="1" i="1" dirty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US" sz="5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Hif1a</a:t>
              </a:r>
              <a:r>
                <a:rPr lang="en-US" sz="5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fl/</a:t>
              </a:r>
              <a:r>
                <a:rPr lang="en-US" sz="500" b="1" i="1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fl</a:t>
              </a:r>
              <a:endParaRPr lang="en-US" sz="5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149C50DC-8880-759D-238B-3C67F17D958C}"/>
                </a:ext>
              </a:extLst>
            </p:cNvPr>
            <p:cNvSpPr txBox="1"/>
            <p:nvPr/>
          </p:nvSpPr>
          <p:spPr>
            <a:xfrm>
              <a:off x="2094276" y="646316"/>
              <a:ext cx="40748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Mrp8</a:t>
              </a:r>
              <a:r>
                <a:rPr lang="en-US" sz="5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Cre</a:t>
              </a:r>
              <a:br>
                <a:rPr lang="en-US" sz="500" b="1" i="1" dirty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US" sz="5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Hif1a</a:t>
              </a:r>
              <a:r>
                <a:rPr lang="en-US" sz="5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fl/</a:t>
              </a:r>
              <a:r>
                <a:rPr lang="en-US" sz="500" b="1" i="1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fl</a:t>
              </a:r>
              <a:endParaRPr lang="en-US" sz="5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97290B12-3FCB-21AB-B2DB-6FFF3103AC58}"/>
                </a:ext>
              </a:extLst>
            </p:cNvPr>
            <p:cNvSpPr txBox="1"/>
            <p:nvPr/>
          </p:nvSpPr>
          <p:spPr>
            <a:xfrm>
              <a:off x="2375987" y="646316"/>
              <a:ext cx="4154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Mrp8</a:t>
              </a:r>
              <a:r>
                <a:rPr lang="en-US" sz="5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Null</a:t>
              </a:r>
              <a:br>
                <a:rPr lang="en-US" sz="500" b="1" i="1" dirty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US" sz="5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Hif1a</a:t>
              </a:r>
              <a:r>
                <a:rPr lang="en-US" sz="5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fl/</a:t>
              </a:r>
              <a:r>
                <a:rPr lang="en-US" sz="500" b="1" i="1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fl</a:t>
              </a:r>
              <a:endParaRPr lang="en-US" sz="5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C28B4A73-7591-2295-4216-BCA5590056A9}"/>
                </a:ext>
              </a:extLst>
            </p:cNvPr>
            <p:cNvSpPr txBox="1"/>
            <p:nvPr/>
          </p:nvSpPr>
          <p:spPr>
            <a:xfrm>
              <a:off x="2659846" y="646316"/>
              <a:ext cx="40748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Mrp8</a:t>
              </a:r>
              <a:r>
                <a:rPr lang="en-US" sz="5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Cre</a:t>
              </a:r>
              <a:br>
                <a:rPr lang="en-US" sz="500" b="1" i="1" dirty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US" sz="5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Hif1a</a:t>
              </a:r>
              <a:r>
                <a:rPr lang="en-US" sz="5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fl/</a:t>
              </a:r>
              <a:r>
                <a:rPr lang="en-US" sz="500" b="1" i="1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fl</a:t>
              </a:r>
              <a:endParaRPr lang="en-US" sz="5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EE791FAC-1C14-BF10-4922-32CC0BA6FD1C}"/>
                </a:ext>
              </a:extLst>
            </p:cNvPr>
            <p:cNvSpPr txBox="1"/>
            <p:nvPr/>
          </p:nvSpPr>
          <p:spPr>
            <a:xfrm>
              <a:off x="3272199" y="684788"/>
              <a:ext cx="32252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BL/6</a:t>
              </a:r>
              <a:endParaRPr lang="en-US" sz="5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B84150BB-50C7-3B36-F492-7539B9F5DFD0}"/>
                </a:ext>
              </a:extLst>
            </p:cNvPr>
            <p:cNvSpPr txBox="1"/>
            <p:nvPr/>
          </p:nvSpPr>
          <p:spPr>
            <a:xfrm>
              <a:off x="3500384" y="646316"/>
              <a:ext cx="4154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Mrp8</a:t>
              </a:r>
              <a:r>
                <a:rPr lang="en-US" sz="5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Null</a:t>
              </a:r>
              <a:br>
                <a:rPr lang="en-US" sz="500" b="1" i="1" dirty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US" sz="5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Hif1a</a:t>
              </a:r>
              <a:r>
                <a:rPr lang="en-US" sz="5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fl/</a:t>
              </a:r>
              <a:r>
                <a:rPr lang="en-US" sz="500" b="1" i="1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fl</a:t>
              </a:r>
              <a:endParaRPr lang="en-US" sz="5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5D067F6E-F2C3-F510-B821-FE478958FB5A}"/>
                </a:ext>
              </a:extLst>
            </p:cNvPr>
            <p:cNvSpPr txBox="1"/>
            <p:nvPr/>
          </p:nvSpPr>
          <p:spPr>
            <a:xfrm>
              <a:off x="3793522" y="646316"/>
              <a:ext cx="40748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Mrp8</a:t>
              </a:r>
              <a:r>
                <a:rPr lang="en-US" sz="5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Cre</a:t>
              </a:r>
              <a:br>
                <a:rPr lang="en-US" sz="500" b="1" i="1" dirty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US" sz="5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Hif1a</a:t>
              </a:r>
              <a:r>
                <a:rPr lang="en-US" sz="5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fl/</a:t>
              </a:r>
              <a:r>
                <a:rPr lang="en-US" sz="500" b="1" i="1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fl</a:t>
              </a:r>
              <a:endParaRPr lang="en-US" sz="5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4" name="Group 63">
              <a:extLst>
                <a:ext uri="{FF2B5EF4-FFF2-40B4-BE49-F238E27FC236}">
                  <a16:creationId xmlns:a16="http://schemas.microsoft.com/office/drawing/2014/main" id="{000260BE-1980-49B3-0D87-7772A0AF7B3E}"/>
                </a:ext>
              </a:extLst>
            </p:cNvPr>
            <p:cNvGrpSpPr/>
            <p:nvPr/>
          </p:nvGrpSpPr>
          <p:grpSpPr>
            <a:xfrm>
              <a:off x="1323103" y="423391"/>
              <a:ext cx="2858780" cy="292182"/>
              <a:chOff x="4454807" y="2736607"/>
              <a:chExt cx="2858780" cy="292182"/>
            </a:xfrm>
          </p:grpSpPr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C305AE10-5DA3-6A41-67BA-748F4B90BE27}"/>
                  </a:ext>
                </a:extLst>
              </p:cNvPr>
              <p:cNvSpPr txBox="1"/>
              <p:nvPr/>
            </p:nvSpPr>
            <p:spPr>
              <a:xfrm>
                <a:off x="5006545" y="2736607"/>
                <a:ext cx="2307042" cy="235962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r>
                  <a:rPr lang="en-US" sz="1400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-        -       +      +       -       +      +       +</a:t>
                </a:r>
                <a:endParaRPr lang="en-US" sz="1200" b="1" baseline="-25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E49C68BE-23F4-05D6-AC5D-3494BB42987A}"/>
                  </a:ext>
                </a:extLst>
              </p:cNvPr>
              <p:cNvSpPr txBox="1"/>
              <p:nvPr/>
            </p:nvSpPr>
            <p:spPr>
              <a:xfrm>
                <a:off x="4454807" y="2751790"/>
                <a:ext cx="601447" cy="276999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oCl</a:t>
                </a:r>
                <a:r>
                  <a:rPr lang="en-US" sz="1200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</p:grp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BEDFDA7F-BD4A-CF13-5119-C1E9503430AF}"/>
                </a:ext>
              </a:extLst>
            </p:cNvPr>
            <p:cNvSpPr txBox="1"/>
            <p:nvPr/>
          </p:nvSpPr>
          <p:spPr>
            <a:xfrm>
              <a:off x="2993027" y="684788"/>
              <a:ext cx="32252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BL/6</a:t>
              </a:r>
              <a:endParaRPr lang="en-US" sz="5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8" name="Group 67">
            <a:extLst>
              <a:ext uri="{FF2B5EF4-FFF2-40B4-BE49-F238E27FC236}">
                <a16:creationId xmlns:a16="http://schemas.microsoft.com/office/drawing/2014/main" id="{85BA058E-BDCC-F158-6C4D-5068B6C1853B}"/>
              </a:ext>
            </a:extLst>
          </p:cNvPr>
          <p:cNvGrpSpPr/>
          <p:nvPr/>
        </p:nvGrpSpPr>
        <p:grpSpPr>
          <a:xfrm>
            <a:off x="6453161" y="2180461"/>
            <a:ext cx="3965646" cy="2493274"/>
            <a:chOff x="937000" y="3255456"/>
            <a:chExt cx="3965646" cy="2493274"/>
          </a:xfrm>
        </p:grpSpPr>
        <p:pic>
          <p:nvPicPr>
            <p:cNvPr id="69" name="Picture 68">
              <a:extLst>
                <a:ext uri="{FF2B5EF4-FFF2-40B4-BE49-F238E27FC236}">
                  <a16:creationId xmlns:a16="http://schemas.microsoft.com/office/drawing/2014/main" id="{F07BE9F9-22A2-B0EE-939B-97F6F3D63F3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653" t="26885" r="42370" b="39356"/>
            <a:stretch/>
          </p:blipFill>
          <p:spPr>
            <a:xfrm>
              <a:off x="1443958" y="3919930"/>
              <a:ext cx="2661220" cy="1828800"/>
            </a:xfrm>
            <a:prstGeom prst="rect">
              <a:avLst/>
            </a:prstGeom>
          </p:spPr>
        </p:pic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79371B3B-FFBE-6A93-762E-1A65CB3863E5}"/>
                </a:ext>
              </a:extLst>
            </p:cNvPr>
            <p:cNvSpPr txBox="1"/>
            <p:nvPr/>
          </p:nvSpPr>
          <p:spPr>
            <a:xfrm>
              <a:off x="937000" y="3898518"/>
              <a:ext cx="70243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260 </a:t>
              </a:r>
              <a:r>
                <a:rPr lang="en-US" sz="1200" b="1" dirty="0" err="1"/>
                <a:t>kDa</a:t>
              </a:r>
              <a:endParaRPr lang="en-US" sz="1200" b="1" dirty="0"/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6EF99FB1-B3E6-2360-6968-4283229E49D6}"/>
                </a:ext>
              </a:extLst>
            </p:cNvPr>
            <p:cNvSpPr txBox="1"/>
            <p:nvPr/>
          </p:nvSpPr>
          <p:spPr>
            <a:xfrm>
              <a:off x="937000" y="4113064"/>
              <a:ext cx="70243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125 </a:t>
              </a:r>
              <a:r>
                <a:rPr lang="en-US" sz="1200" b="1" dirty="0" err="1"/>
                <a:t>kDa</a:t>
              </a:r>
              <a:endParaRPr lang="en-US" sz="1200" b="1" dirty="0"/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6F8CCB76-F885-1DCE-4C98-7FC05CB6143C}"/>
                </a:ext>
              </a:extLst>
            </p:cNvPr>
            <p:cNvSpPr txBox="1"/>
            <p:nvPr/>
          </p:nvSpPr>
          <p:spPr>
            <a:xfrm>
              <a:off x="1015547" y="4294198"/>
              <a:ext cx="62388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90 </a:t>
              </a:r>
              <a:r>
                <a:rPr lang="en-US" sz="1200" b="1" dirty="0" err="1"/>
                <a:t>kDa</a:t>
              </a:r>
              <a:endParaRPr lang="en-US" sz="1200" b="1" dirty="0"/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9D467002-65DA-F5AD-5E7D-BAB1DAE44347}"/>
                </a:ext>
              </a:extLst>
            </p:cNvPr>
            <p:cNvSpPr txBox="1"/>
            <p:nvPr/>
          </p:nvSpPr>
          <p:spPr>
            <a:xfrm>
              <a:off x="1015547" y="4930897"/>
              <a:ext cx="62388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38 </a:t>
              </a:r>
              <a:r>
                <a:rPr lang="en-US" sz="1200" b="1" dirty="0" err="1"/>
                <a:t>kDa</a:t>
              </a:r>
              <a:endParaRPr lang="en-US" sz="1200" b="1" dirty="0"/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FA281B4D-62F0-20CB-B996-696C7F05C8EA}"/>
                </a:ext>
              </a:extLst>
            </p:cNvPr>
            <p:cNvSpPr txBox="1"/>
            <p:nvPr/>
          </p:nvSpPr>
          <p:spPr>
            <a:xfrm>
              <a:off x="4102427" y="4517709"/>
              <a:ext cx="80021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7D41C3CA-B60D-7C36-8D4D-F8EE75C4F5CB}"/>
                </a:ext>
              </a:extLst>
            </p:cNvPr>
            <p:cNvSpPr txBox="1"/>
            <p:nvPr/>
          </p:nvSpPr>
          <p:spPr>
            <a:xfrm>
              <a:off x="1837449" y="3255456"/>
              <a:ext cx="110083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G-MDSC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EB9A71CD-0E16-7E2C-32EC-5B129282B2D4}"/>
                </a:ext>
              </a:extLst>
            </p:cNvPr>
            <p:cNvSpPr txBox="1"/>
            <p:nvPr/>
          </p:nvSpPr>
          <p:spPr>
            <a:xfrm>
              <a:off x="3009302" y="3255456"/>
              <a:ext cx="10386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r>
                <a:rPr lang="el-G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φ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7" name="Straight Connector 76">
              <a:extLst>
                <a:ext uri="{FF2B5EF4-FFF2-40B4-BE49-F238E27FC236}">
                  <a16:creationId xmlns:a16="http://schemas.microsoft.com/office/drawing/2014/main" id="{01809FF0-0188-1A31-58A9-D65963FC8985}"/>
                </a:ext>
              </a:extLst>
            </p:cNvPr>
            <p:cNvCxnSpPr>
              <a:cxnSpLocks/>
            </p:cNvCxnSpPr>
            <p:nvPr/>
          </p:nvCxnSpPr>
          <p:spPr>
            <a:xfrm>
              <a:off x="1819693" y="3521886"/>
              <a:ext cx="1100831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Straight Connector 77">
              <a:extLst>
                <a:ext uri="{FF2B5EF4-FFF2-40B4-BE49-F238E27FC236}">
                  <a16:creationId xmlns:a16="http://schemas.microsoft.com/office/drawing/2014/main" id="{DACF813C-9D65-B4F7-CC50-CA62225FA09D}"/>
                </a:ext>
              </a:extLst>
            </p:cNvPr>
            <p:cNvCxnSpPr>
              <a:cxnSpLocks/>
            </p:cNvCxnSpPr>
            <p:nvPr/>
          </p:nvCxnSpPr>
          <p:spPr>
            <a:xfrm>
              <a:off x="2981594" y="3521886"/>
              <a:ext cx="1100831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AB415B44-18A9-3C5F-6353-DB71DA99D6E1}"/>
                </a:ext>
              </a:extLst>
            </p:cNvPr>
            <p:cNvSpPr txBox="1"/>
            <p:nvPr/>
          </p:nvSpPr>
          <p:spPr>
            <a:xfrm>
              <a:off x="1730017" y="3688381"/>
              <a:ext cx="4154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Mrp8</a:t>
              </a:r>
              <a:r>
                <a:rPr lang="en-US" sz="5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Null</a:t>
              </a:r>
              <a:br>
                <a:rPr lang="en-US" sz="500" b="1" i="1" dirty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US" sz="5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Hif1a</a:t>
              </a:r>
              <a:r>
                <a:rPr lang="en-US" sz="5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fl/</a:t>
              </a:r>
              <a:r>
                <a:rPr lang="en-US" sz="500" b="1" i="1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fl</a:t>
              </a:r>
              <a:endParaRPr lang="en-US" sz="5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BCB1DA96-27A4-4280-0146-F8C6DAC34DE1}"/>
                </a:ext>
              </a:extLst>
            </p:cNvPr>
            <p:cNvSpPr txBox="1"/>
            <p:nvPr/>
          </p:nvSpPr>
          <p:spPr>
            <a:xfrm>
              <a:off x="2038076" y="3688381"/>
              <a:ext cx="40748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Mrp8</a:t>
              </a:r>
              <a:r>
                <a:rPr lang="en-US" sz="5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Cre</a:t>
              </a:r>
              <a:br>
                <a:rPr lang="en-US" sz="500" b="1" i="1" dirty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US" sz="5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Hif1a</a:t>
              </a:r>
              <a:r>
                <a:rPr lang="en-US" sz="5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fl/</a:t>
              </a:r>
              <a:r>
                <a:rPr lang="en-US" sz="500" b="1" i="1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fl</a:t>
              </a:r>
              <a:endParaRPr lang="en-US" sz="5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C1CB4663-D9D9-0FE0-D9F8-C478B80A4F32}"/>
                </a:ext>
              </a:extLst>
            </p:cNvPr>
            <p:cNvSpPr txBox="1"/>
            <p:nvPr/>
          </p:nvSpPr>
          <p:spPr>
            <a:xfrm>
              <a:off x="2319787" y="3688381"/>
              <a:ext cx="4154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Mrp8</a:t>
              </a:r>
              <a:r>
                <a:rPr lang="en-US" sz="5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Null</a:t>
              </a:r>
              <a:br>
                <a:rPr lang="en-US" sz="500" b="1" i="1" dirty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US" sz="5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Hif1a</a:t>
              </a:r>
              <a:r>
                <a:rPr lang="en-US" sz="5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fl/</a:t>
              </a:r>
              <a:r>
                <a:rPr lang="en-US" sz="500" b="1" i="1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fl</a:t>
              </a:r>
              <a:endParaRPr lang="en-US" sz="5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E0B085A5-60C5-0259-FF11-8B0572F5B18B}"/>
                </a:ext>
              </a:extLst>
            </p:cNvPr>
            <p:cNvSpPr txBox="1"/>
            <p:nvPr/>
          </p:nvSpPr>
          <p:spPr>
            <a:xfrm>
              <a:off x="2603646" y="3688381"/>
              <a:ext cx="40748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Mrp8</a:t>
              </a:r>
              <a:r>
                <a:rPr lang="en-US" sz="5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Cre</a:t>
              </a:r>
              <a:br>
                <a:rPr lang="en-US" sz="500" b="1" i="1" dirty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US" sz="5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Hif1a</a:t>
              </a:r>
              <a:r>
                <a:rPr lang="en-US" sz="5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fl/</a:t>
              </a:r>
              <a:r>
                <a:rPr lang="en-US" sz="500" b="1" i="1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fl</a:t>
              </a:r>
              <a:endParaRPr lang="en-US" sz="5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5F2430AD-3CC3-CE2A-B211-7A29D2756197}"/>
                </a:ext>
              </a:extLst>
            </p:cNvPr>
            <p:cNvSpPr txBox="1"/>
            <p:nvPr/>
          </p:nvSpPr>
          <p:spPr>
            <a:xfrm>
              <a:off x="3215999" y="3726853"/>
              <a:ext cx="32252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BL/6</a:t>
              </a:r>
              <a:endParaRPr lang="en-US" sz="5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11CEAC92-3DD1-7274-9EB2-B6D1235C57A1}"/>
                </a:ext>
              </a:extLst>
            </p:cNvPr>
            <p:cNvSpPr txBox="1"/>
            <p:nvPr/>
          </p:nvSpPr>
          <p:spPr>
            <a:xfrm>
              <a:off x="3444184" y="3688381"/>
              <a:ext cx="4154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Mrp8</a:t>
              </a:r>
              <a:r>
                <a:rPr lang="en-US" sz="5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Null</a:t>
              </a:r>
              <a:br>
                <a:rPr lang="en-US" sz="500" b="1" i="1" dirty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US" sz="5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Hif1a</a:t>
              </a:r>
              <a:r>
                <a:rPr lang="en-US" sz="5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fl/</a:t>
              </a:r>
              <a:r>
                <a:rPr lang="en-US" sz="500" b="1" i="1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fl</a:t>
              </a:r>
              <a:endParaRPr lang="en-US" sz="5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FF4BAEEA-D595-09ED-5B22-B638FF37EC62}"/>
                </a:ext>
              </a:extLst>
            </p:cNvPr>
            <p:cNvSpPr txBox="1"/>
            <p:nvPr/>
          </p:nvSpPr>
          <p:spPr>
            <a:xfrm>
              <a:off x="3737322" y="3688381"/>
              <a:ext cx="40748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Mrp8</a:t>
              </a:r>
              <a:r>
                <a:rPr lang="en-US" sz="5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Cre</a:t>
              </a:r>
              <a:br>
                <a:rPr lang="en-US" sz="500" b="1" i="1" dirty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US" sz="5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Hif1a</a:t>
              </a:r>
              <a:r>
                <a:rPr lang="en-US" sz="500" b="1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fl/</a:t>
              </a:r>
              <a:r>
                <a:rPr lang="en-US" sz="500" b="1" i="1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fl</a:t>
              </a:r>
              <a:endParaRPr lang="en-US" sz="5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86" name="Group 85">
              <a:extLst>
                <a:ext uri="{FF2B5EF4-FFF2-40B4-BE49-F238E27FC236}">
                  <a16:creationId xmlns:a16="http://schemas.microsoft.com/office/drawing/2014/main" id="{875AF1FA-B8E4-AB54-381D-9D6713EFBCB5}"/>
                </a:ext>
              </a:extLst>
            </p:cNvPr>
            <p:cNvGrpSpPr/>
            <p:nvPr/>
          </p:nvGrpSpPr>
          <p:grpSpPr>
            <a:xfrm>
              <a:off x="1266903" y="3465456"/>
              <a:ext cx="2858780" cy="292182"/>
              <a:chOff x="4454807" y="2736607"/>
              <a:chExt cx="2858780" cy="292182"/>
            </a:xfrm>
          </p:grpSpPr>
          <p:sp>
            <p:nvSpPr>
              <p:cNvPr id="88" name="TextBox 87">
                <a:extLst>
                  <a:ext uri="{FF2B5EF4-FFF2-40B4-BE49-F238E27FC236}">
                    <a16:creationId xmlns:a16="http://schemas.microsoft.com/office/drawing/2014/main" id="{E4680393-A3BD-E608-1948-5B659B1268C7}"/>
                  </a:ext>
                </a:extLst>
              </p:cNvPr>
              <p:cNvSpPr txBox="1"/>
              <p:nvPr/>
            </p:nvSpPr>
            <p:spPr>
              <a:xfrm>
                <a:off x="5006545" y="2736607"/>
                <a:ext cx="2307042" cy="235962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r>
                  <a:rPr lang="en-US" sz="1400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-        -       +      +       -       +      +       +</a:t>
                </a:r>
                <a:endParaRPr lang="en-US" sz="1200" b="1" baseline="-25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9" name="TextBox 88">
                <a:extLst>
                  <a:ext uri="{FF2B5EF4-FFF2-40B4-BE49-F238E27FC236}">
                    <a16:creationId xmlns:a16="http://schemas.microsoft.com/office/drawing/2014/main" id="{50634D90-038B-2EFF-AF8C-167C78375713}"/>
                  </a:ext>
                </a:extLst>
              </p:cNvPr>
              <p:cNvSpPr txBox="1"/>
              <p:nvPr/>
            </p:nvSpPr>
            <p:spPr>
              <a:xfrm>
                <a:off x="4454807" y="2751790"/>
                <a:ext cx="601447" cy="276999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oCl</a:t>
                </a:r>
                <a:r>
                  <a:rPr lang="en-US" sz="1200" b="1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</p:grp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4A237814-4994-E977-9792-75E66BA10A4B}"/>
                </a:ext>
              </a:extLst>
            </p:cNvPr>
            <p:cNvSpPr txBox="1"/>
            <p:nvPr/>
          </p:nvSpPr>
          <p:spPr>
            <a:xfrm>
              <a:off x="2936827" y="3726853"/>
              <a:ext cx="322524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BL/6</a:t>
              </a:r>
              <a:endParaRPr lang="en-US" sz="500" b="1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D3107955-42A5-6AC5-00A6-0FA306F5478C}"/>
              </a:ext>
            </a:extLst>
          </p:cNvPr>
          <p:cNvSpPr txBox="1"/>
          <p:nvPr/>
        </p:nvSpPr>
        <p:spPr>
          <a:xfrm>
            <a:off x="2203866" y="1417110"/>
            <a:ext cx="325040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ull unedited gel for HIF-1a Supplemental Figure B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E91278E-B787-7D8C-5A35-6616238C40A6}"/>
              </a:ext>
            </a:extLst>
          </p:cNvPr>
          <p:cNvSpPr txBox="1"/>
          <p:nvPr/>
        </p:nvSpPr>
        <p:spPr>
          <a:xfrm>
            <a:off x="6665526" y="1415836"/>
            <a:ext cx="325040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ull unedited gel for </a:t>
            </a:r>
            <a:r>
              <a:rPr lang="el-GR" sz="16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-actin Supplemental Figure B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C54EF5D3-E9F3-9C24-382C-6DB75A75B234}"/>
              </a:ext>
            </a:extLst>
          </p:cNvPr>
          <p:cNvSpPr/>
          <p:nvPr/>
        </p:nvSpPr>
        <p:spPr>
          <a:xfrm>
            <a:off x="2701865" y="3171642"/>
            <a:ext cx="2365085" cy="444089"/>
          </a:xfrm>
          <a:prstGeom prst="rect">
            <a:avLst/>
          </a:prstGeom>
          <a:noFill/>
          <a:ln w="190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BF6B6795-4478-4570-B370-F77D1C03E6D2}"/>
              </a:ext>
            </a:extLst>
          </p:cNvPr>
          <p:cNvSpPr/>
          <p:nvPr/>
        </p:nvSpPr>
        <p:spPr>
          <a:xfrm>
            <a:off x="7272874" y="3855903"/>
            <a:ext cx="2388092" cy="407336"/>
          </a:xfrm>
          <a:prstGeom prst="rect">
            <a:avLst/>
          </a:prstGeom>
          <a:noFill/>
          <a:ln w="19050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2879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0</TotalTime>
  <Words>132</Words>
  <Application>Microsoft Office PowerPoint</Application>
  <PresentationFormat>Widescreen</PresentationFormat>
  <Paragraphs>3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rumugam, Prabhakar</dc:creator>
  <cp:lastModifiedBy>Kielian, Tammy L</cp:lastModifiedBy>
  <cp:revision>11</cp:revision>
  <dcterms:created xsi:type="dcterms:W3CDTF">2023-01-26T17:46:14Z</dcterms:created>
  <dcterms:modified xsi:type="dcterms:W3CDTF">2023-12-13T16:43:44Z</dcterms:modified>
</cp:coreProperties>
</file>